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8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0E5DD5-E267-4190-B995-E52938E7D6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671CE07-B6DA-49E7-B0D9-E90DED56D7E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1AB73C-F046-4C13-A49C-F1351C1B6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951B46A-A35C-44AB-9136-71DB15029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DC68F1-770E-4DD2-BEA1-DC45CED0E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18017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2B34A0-1BBB-4BF2-BA62-9650104E8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1F1A804-1884-4BE1-869E-9628FBFC9F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179245-580C-4C65-A76A-991EE9A44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EA1F379-0334-4402-918A-BEFE9D670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E0D2F18-4C8F-43C8-9AE1-5309404C0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2029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40F54A4-BB89-419E-94E7-5ECC7927B9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D6B0566-4045-4DFE-81D7-FE46884604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8F8849A-1A97-4BC4-9C37-2566B4F43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7BAEFA-7CF2-4598-8E63-89896DEE4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2457C1-C067-44E2-A2D4-A04B82322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82267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942168-1F27-4600-9FEB-7B1B84B16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6C8486C-4256-43CE-B281-7EFC16A10C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472711-AEB0-48FE-8394-C3BA5A2E1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18B871-FE85-4417-9B98-0D0F77310A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7068E7E-9916-48DD-8B76-C9ABCE988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21040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1426C0-D3DE-442A-91AC-4CF7B8D32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2852F8-D3D9-42D1-A3F5-A84C3B1B7F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620D22-04A8-4A8C-8023-AC12FA837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98D715-5A69-4DF8-BF4B-79D89D5BE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6F0CC5-2149-4A89-BE37-D5FB17E5B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4472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E3F57D-7A3D-45F1-9B6E-043A13A630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385E780-866B-437D-8FAD-89401C3AB8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215A9A8-7196-45AA-AEE0-F8044956C9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4808D7-6A68-4ECE-A5C1-D871AD2A1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4A27121-9FBD-438E-B16F-A062BBE9B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FBF2F24-0809-448A-81B7-9A76726FD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1841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CAEA537-7CBC-4A82-AB3C-2E78F2283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E3A439E-FBE3-4E6F-96FB-63F8243DB4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0B3B2D1-3F80-4D6E-84B8-39951796ED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4BF5FEF-6B7D-4742-B555-D6DEDD40C9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4475FEA-25BC-46C2-8FB9-F7DFA1C6C0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8F3AE9D-1CB4-4E70-913B-55CC65524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FD73DC3-1760-4D08-8A8E-DA4AFB0642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305C748-EE33-4703-908B-0A7DD422B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6140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26A7C08-3584-4CB0-92BC-92A7023491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0ADABC9-4D73-4BCC-BC65-E10F2B39C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40C5C1D-CBCE-4382-B0C3-94036FC98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3E93253-A3F4-4374-B431-89B14BCA2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611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560BCD2-DDF0-4D7E-8DBE-05A4AC0E6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85045D9-5B18-40DA-ACD5-2BDEE3200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053F058-8447-4047-9856-29339E9F9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5460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6EBB68-4A56-4A5D-ABCB-8310239FC6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54772FF-BA7B-4CE6-8C99-5329514E0BC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7486CF5-30A7-4FBE-B91F-A53BC18CE5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DE23D38-AD1E-4BFD-8CFE-F8BE927A9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869ABF5-E988-437C-897C-5CAFEB1AC3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BCA3FB-8A43-4CF8-90A9-6F7DF6F24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8926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8134C8-A6DA-4E0B-9F4F-718D1F525D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E60735-E317-4A28-9804-476D26D559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091C9D5-690E-4D96-82F0-F0FBA053A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22703E-5915-4717-87FB-F9FC21898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54FDA8B-67AD-441D-B84E-B1ED584BD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0CCAAC-06FE-44A9-AD8C-2D28F64CF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5094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C997D2D-5261-4677-A64A-5D0D00C738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40C8E9-238F-40FC-8489-369DC161EA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66526D-0F7A-4D2D-B55B-F01DF30F617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42C750-9F58-4EEC-A10E-2C49FBF8C460}" type="datetimeFigureOut">
              <a:rPr lang="zh-CN" altLang="en-US" smtClean="0"/>
              <a:t>2020/10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FE231F-BCF3-4DC7-A03D-722C0D4CB8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EA5481-7858-41EC-9F94-B7D2E3E5EF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31C927-8EB2-43F7-AB8E-4D6712F511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9675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735A07-ADA8-4F07-9440-9A784FCBDB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1290899"/>
          </a:xfrm>
        </p:spPr>
        <p:txBody>
          <a:bodyPr/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s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EA9C59C-57BB-4E53-8595-C20AC2A475B6}"/>
              </a:ext>
            </a:extLst>
          </p:cNvPr>
          <p:cNvSpPr txBox="1"/>
          <p:nvPr/>
        </p:nvSpPr>
        <p:spPr>
          <a:xfrm>
            <a:off x="2337848" y="3346516"/>
            <a:ext cx="81698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FC map of the spherical region within a 3 mm radius of the right anterior cingulum cortex(x=3,y=42,z=27, MNI coordinates)</a:t>
            </a:r>
            <a:endParaRPr lang="zh-CN" altLang="en-US" sz="2400" dirty="0"/>
          </a:p>
        </p:txBody>
      </p:sp>
    </p:spTree>
    <p:extLst>
      <p:ext uri="{BB962C8B-B14F-4D97-AF65-F5344CB8AC3E}">
        <p14:creationId xmlns:p14="http://schemas.microsoft.com/office/powerpoint/2010/main" val="31349187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5703F036-F75E-4EB5-81F8-D471DE5E715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1951" y="901065"/>
            <a:ext cx="6620018" cy="5291138"/>
          </a:xfr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80B20B1-77F9-41E0-9401-B8018196F9CB}"/>
              </a:ext>
            </a:extLst>
          </p:cNvPr>
          <p:cNvSpPr txBox="1"/>
          <p:nvPr/>
        </p:nvSpPr>
        <p:spPr>
          <a:xfrm>
            <a:off x="7758260" y="2828835"/>
            <a:ext cx="417607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Two-sample t-test results of right ACC seed FC analyses differences between MSA-D and HCs.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lphaSim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multiple comparisons corrected p&lt; 0.001.</a:t>
            </a:r>
            <a:endParaRPr lang="zh-CN" altLang="zh-CN" sz="18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692746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70F93F53-74EF-4A17-AB58-D0F403A2766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6438" y="883920"/>
            <a:ext cx="6679604" cy="5338763"/>
          </a:xfr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96359ACB-FEF6-4325-91AC-C4B7E82FCA9F}"/>
              </a:ext>
            </a:extLst>
          </p:cNvPr>
          <p:cNvSpPr txBox="1"/>
          <p:nvPr/>
        </p:nvSpPr>
        <p:spPr>
          <a:xfrm>
            <a:off x="7777113" y="2552804"/>
            <a:ext cx="414543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wo-sample t-test results of right ACC seed FC analyses differences between MSA-ND and HCs.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lphaSim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multiple comparisons corrected p&lt; 0.001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81266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>
            <a:extLst>
              <a:ext uri="{FF2B5EF4-FFF2-40B4-BE49-F238E27FC236}">
                <a16:creationId xmlns:a16="http://schemas.microsoft.com/office/drawing/2014/main" id="{D4F8D396-9ECF-4FF6-A8E7-16EF3A8145C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173" y="615156"/>
            <a:ext cx="7041093" cy="5627688"/>
          </a:xfr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D67A4AAC-B4B4-4F26-91A6-0B508CEB5C41}"/>
              </a:ext>
            </a:extLst>
          </p:cNvPr>
          <p:cNvSpPr txBox="1"/>
          <p:nvPr/>
        </p:nvSpPr>
        <p:spPr>
          <a:xfrm>
            <a:off x="8012782" y="2526631"/>
            <a:ext cx="393804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wo-sample t-test results of right ACC seed FC analyses differences between MSA-D and MSA-ND. </a:t>
            </a:r>
            <a:r>
              <a:rPr lang="en-US" altLang="zh-CN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lphaSim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multiple comparisons corrected p&lt; 0.001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36822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06</Words>
  <Application>Microsoft Office PowerPoint</Application>
  <PresentationFormat>宽屏</PresentationFormat>
  <Paragraphs>5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Times New Roman</vt:lpstr>
      <vt:lpstr>Office 主题​​</vt:lpstr>
      <vt:lpstr>supplementary materials 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s </dc:title>
  <dc:creator>杨 华光</dc:creator>
  <cp:lastModifiedBy>杨 华光</cp:lastModifiedBy>
  <cp:revision>2</cp:revision>
  <dcterms:created xsi:type="dcterms:W3CDTF">2020-10-28T13:06:01Z</dcterms:created>
  <dcterms:modified xsi:type="dcterms:W3CDTF">2020-10-28T13:17:51Z</dcterms:modified>
</cp:coreProperties>
</file>